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197"/>
  </p:normalViewPr>
  <p:slideViewPr>
    <p:cSldViewPr snapToGrid="0" snapToObjects="1">
      <p:cViewPr varScale="1">
        <p:scale>
          <a:sx n="119" d="100"/>
          <a:sy n="119" d="100"/>
        </p:scale>
        <p:origin x="2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connorlewis/Desktop/Tierney%20Lab/qRT-PCR/Analyses/CCDC22%20expression%20in%20WT%20ccdc22-1%20and%20ccdc93-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connorlewis/Desktop/Tierney%20Lab/qRT-PCR/Analyses/CCDC93%20Expression%20in%20WT%20ccdc22-1%20and%20ccdc93-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connorlewis/Desktop/Tierney%20Lab/qRT-PCR/Analyses/93%20Expression%20in%20WT%20vs%2093-2%20Analysi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800" i="1"/>
              <a:t>CCDC22</a:t>
            </a:r>
            <a:r>
              <a:rPr lang="en-US" sz="800" i="0" baseline="0"/>
              <a:t> Expression in WT and </a:t>
            </a:r>
            <a:r>
              <a:rPr lang="en-US" sz="800" i="1" baseline="0"/>
              <a:t>ccdc22-1</a:t>
            </a:r>
            <a:endParaRPr lang="en-US" sz="800" i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Y$6:$Y$7</c:f>
                <c:numCache>
                  <c:formatCode>General</c:formatCode>
                  <c:ptCount val="2"/>
                  <c:pt idx="0">
                    <c:v>0.1694776909643379</c:v>
                  </c:pt>
                  <c:pt idx="1">
                    <c:v>2.1353457630434766E-2</c:v>
                  </c:pt>
                </c:numCache>
              </c:numRef>
            </c:plus>
            <c:minus>
              <c:numRef>
                <c:f>Sheet1!$Y$6:$Y$7</c:f>
                <c:numCache>
                  <c:formatCode>General</c:formatCode>
                  <c:ptCount val="2"/>
                  <c:pt idx="0">
                    <c:v>0.1694776909643379</c:v>
                  </c:pt>
                  <c:pt idx="1">
                    <c:v>2.135345763043476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W$6:$W$7</c:f>
              <c:strCache>
                <c:ptCount val="2"/>
                <c:pt idx="0">
                  <c:v>WT</c:v>
                </c:pt>
                <c:pt idx="1">
                  <c:v>ccdc22-1</c:v>
                </c:pt>
              </c:strCache>
            </c:strRef>
          </c:cat>
          <c:val>
            <c:numRef>
              <c:f>Sheet1!$X$6:$X$7</c:f>
              <c:numCache>
                <c:formatCode>General</c:formatCode>
                <c:ptCount val="2"/>
                <c:pt idx="0">
                  <c:v>1</c:v>
                </c:pt>
                <c:pt idx="1">
                  <c:v>9.177072154486427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14-A349-8E94-DA49956E07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77363664"/>
        <c:axId val="777104992"/>
      </c:barChart>
      <c:catAx>
        <c:axId val="777363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7104992"/>
        <c:crosses val="autoZero"/>
        <c:auto val="1"/>
        <c:lblAlgn val="ctr"/>
        <c:lblOffset val="100"/>
        <c:noMultiLvlLbl val="0"/>
      </c:catAx>
      <c:valAx>
        <c:axId val="7771049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800"/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9.6243230134993127E-2"/>
              <c:y val="0.2993085057031761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7363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800" i="1" dirty="0"/>
              <a:t>CCDC93</a:t>
            </a:r>
            <a:r>
              <a:rPr lang="en-US" sz="800" i="0" dirty="0"/>
              <a:t> Expression in WT and </a:t>
            </a:r>
            <a:r>
              <a:rPr lang="en-US" sz="800" i="1" dirty="0"/>
              <a:t>ccdc93-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U$7,Sheet1!$U$9)</c:f>
                <c:numCache>
                  <c:formatCode>General</c:formatCode>
                  <c:ptCount val="2"/>
                  <c:pt idx="0">
                    <c:v>9.7593704236105333E-2</c:v>
                  </c:pt>
                  <c:pt idx="1">
                    <c:v>4.8946175689138295E-5</c:v>
                  </c:pt>
                </c:numCache>
              </c:numRef>
            </c:plus>
            <c:minus>
              <c:numRef>
                <c:f>(Sheet1!$U$7,Sheet1!$U$9)</c:f>
                <c:numCache>
                  <c:formatCode>General</c:formatCode>
                  <c:ptCount val="2"/>
                  <c:pt idx="0">
                    <c:v>9.7593704236105333E-2</c:v>
                  </c:pt>
                  <c:pt idx="1">
                    <c:v>4.8946175689138295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Y$7:$Y$8</c:f>
              <c:strCache>
                <c:ptCount val="2"/>
                <c:pt idx="0">
                  <c:v>WT</c:v>
                </c:pt>
                <c:pt idx="1">
                  <c:v>ccdc93-1</c:v>
                </c:pt>
              </c:strCache>
            </c:strRef>
          </c:cat>
          <c:val>
            <c:numRef>
              <c:f>Sheet1!$Z$7:$Z$8</c:f>
              <c:numCache>
                <c:formatCode>General</c:formatCode>
                <c:ptCount val="2"/>
                <c:pt idx="0">
                  <c:v>1</c:v>
                </c:pt>
                <c:pt idx="1">
                  <c:v>1.9944311983955806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56-4947-8B01-6AE0647D87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77959408"/>
        <c:axId val="777961056"/>
      </c:barChart>
      <c:catAx>
        <c:axId val="777959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7961056"/>
        <c:crosses val="autoZero"/>
        <c:auto val="1"/>
        <c:lblAlgn val="ctr"/>
        <c:lblOffset val="100"/>
        <c:noMultiLvlLbl val="0"/>
      </c:catAx>
      <c:valAx>
        <c:axId val="777961056"/>
        <c:scaling>
          <c:orientation val="minMax"/>
          <c:max val="1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800" dirty="0"/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8.8222960957077032E-2"/>
              <c:y val="0.290381917403051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79594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800" i="1" dirty="0"/>
              <a:t>CCDC93</a:t>
            </a:r>
            <a:r>
              <a:rPr lang="en-US" sz="800" dirty="0"/>
              <a:t> Expression in WT and</a:t>
            </a:r>
            <a:r>
              <a:rPr lang="en-US" sz="800" baseline="0" dirty="0"/>
              <a:t> </a:t>
            </a:r>
            <a:r>
              <a:rPr lang="en-US" sz="800" i="1" baseline="0" dirty="0"/>
              <a:t>ccdc93-2</a:t>
            </a:r>
            <a:endParaRPr lang="en-US" sz="8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R$7:$R$8</c:f>
                <c:numCache>
                  <c:formatCode>General</c:formatCode>
                  <c:ptCount val="2"/>
                  <c:pt idx="0">
                    <c:v>8.8289364741302001E-2</c:v>
                  </c:pt>
                  <c:pt idx="1">
                    <c:v>2.6587094314171416E-3</c:v>
                  </c:pt>
                </c:numCache>
              </c:numRef>
            </c:plus>
            <c:minus>
              <c:numRef>
                <c:f>Sheet1!$R$7:$R$8</c:f>
                <c:numCache>
                  <c:formatCode>General</c:formatCode>
                  <c:ptCount val="2"/>
                  <c:pt idx="0">
                    <c:v>8.8289364741302001E-2</c:v>
                  </c:pt>
                  <c:pt idx="1">
                    <c:v>2.658709431417141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7:$P$8</c:f>
              <c:strCache>
                <c:ptCount val="2"/>
                <c:pt idx="0">
                  <c:v>WT</c:v>
                </c:pt>
                <c:pt idx="1">
                  <c:v>93-2</c:v>
                </c:pt>
              </c:strCache>
            </c:strRef>
          </c:cat>
          <c:val>
            <c:numRef>
              <c:f>Sheet1!$Q$7:$Q$8</c:f>
              <c:numCache>
                <c:formatCode>0.00</c:formatCode>
                <c:ptCount val="2"/>
                <c:pt idx="0">
                  <c:v>1.0079377802797358</c:v>
                </c:pt>
                <c:pt idx="1">
                  <c:v>1.16829885638947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30-8946-BB83-46948AB768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95819695"/>
        <c:axId val="1395821343"/>
      </c:barChart>
      <c:catAx>
        <c:axId val="13958196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5821343"/>
        <c:crosses val="autoZero"/>
        <c:auto val="1"/>
        <c:lblAlgn val="ctr"/>
        <c:lblOffset val="100"/>
        <c:noMultiLvlLbl val="0"/>
      </c:catAx>
      <c:valAx>
        <c:axId val="139582134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800" dirty="0"/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8.8222960957077032E-2"/>
              <c:y val="0.3082350940033007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5819695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9C8733-CD06-CD43-BCA8-928C64FBCF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91EC651-1856-4F44-8E1B-DEE88168C7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ECD1A4-EFB8-574B-88FB-AF1EB406AD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A7880-7FED-EC42-A631-90F2C280090A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C1740E-9F63-E64E-9CAE-07BE158F0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F7853A-E46D-2447-8359-B3DAD2501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87A67-1E05-7E41-BAD6-42C10BA68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859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E9FF1-372C-7C41-B0EA-807BCBEC2D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72677F-9A58-4F42-B172-5A50B9FA65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A35A24-E66A-6E46-854A-2B11549735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A7880-7FED-EC42-A631-90F2C280090A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CACC6F-3FF0-0B4F-AF87-113061C1F0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954698-DC2B-7A41-8318-9C1FAFAAC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87A67-1E05-7E41-BAD6-42C10BA68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225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ED1ACEF-253A-5A4A-8C43-132D8F742C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88115A-8030-D549-990A-62D1E99C46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34FABF-EEA0-B247-92F8-EA55146BA9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A7880-7FED-EC42-A631-90F2C280090A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BE2930-4783-FC48-AFD4-75673BFB0B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E61234-5F25-E04A-B801-5A7F08606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87A67-1E05-7E41-BAD6-42C10BA68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959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44D80B-C5A8-154E-866F-A5970AB347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00521A-6FEC-9E49-B2B8-B1D27FBC9D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CD978C-FEBF-8542-AFB8-32F0BB5570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A7880-7FED-EC42-A631-90F2C280090A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B391EC-C030-1D47-AC83-14C99C201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FFBDC9-10E1-9745-B238-9E99A6749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87A67-1E05-7E41-BAD6-42C10BA68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7582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C4B3C-2156-CE44-9DFB-B00FAB2FE7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22D1BD-2753-B145-913A-9AFB16CDB7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554201-8BB8-3940-B552-85184FE83F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A7880-7FED-EC42-A631-90F2C280090A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55911F-C65C-1D41-9289-FACF48EAE6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2FDF62-23FF-2F46-8602-4FA2371F1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87A67-1E05-7E41-BAD6-42C10BA68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886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6643A-F4BA-1D40-BCC5-E60CBCA0F2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4C77DF-AE59-7442-A274-62AF6F60FA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11DFCD-EA1A-6B4F-B6E1-67EA0AE673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05C8F5-4ED5-FC47-AD44-E4CFD1A259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A7880-7FED-EC42-A631-90F2C280090A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B68414-B0AC-AE43-9B3E-A42C840B62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50276F-F80E-8242-8D5B-F11869D92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87A67-1E05-7E41-BAD6-42C10BA68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822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D26D4A-A953-A544-B840-78B9CF9084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53F016-CE2B-2348-B7D8-43DAB43B8C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87F49E-15F0-0F4F-B1F7-5E95BAD3D7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9B4595A-05F2-434E-BC8F-098360CEEE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1D135C6-1469-6F42-AB53-7D67A5DCCC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AD209F-ED3A-A94D-B83D-5A3FA321DB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A7880-7FED-EC42-A631-90F2C280090A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DCD1C22-6A3E-6B46-83CB-86CEDD2BC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27B4547-7991-9F4F-8BC7-6EDE322DC8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87A67-1E05-7E41-BAD6-42C10BA68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061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A9692E-2B17-2345-A37A-14FDFFC3AC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632EB93-CA44-C14B-AFDC-F0D040957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A7880-7FED-EC42-A631-90F2C280090A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1A151BB-1F09-5F43-B137-2568DBCD7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C6C289C-F68C-3E47-B754-59B4226218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87A67-1E05-7E41-BAD6-42C10BA68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767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205435-20FA-2D4A-A861-F36D60163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A7880-7FED-EC42-A631-90F2C280090A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422D82B-3C6D-3042-9388-FBD298DFCA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76E2475-6638-E84A-8B54-2B5161CA1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87A67-1E05-7E41-BAD6-42C10BA68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244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D3C501-487A-3A4A-9471-98E3F30936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2BC1FA-90C5-6D42-AEE3-C435C4B777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E3848B-8762-3D41-9DA7-EDF419A89C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95F757-36AD-6E42-A179-3065CCFCFB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A7880-7FED-EC42-A631-90F2C280090A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557E44-49F5-6246-A2E5-74F7EFE19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771D04-6E3E-9F43-AB35-42DF0F2BE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87A67-1E05-7E41-BAD6-42C10BA68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513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CF96DD-141E-9742-A54F-D5A800B4A2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7B76482-21E8-6045-8F3D-1E8D0ECBE8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74DDD4-4BF7-AF4A-9DBB-922560FF86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EF98FC-8097-2149-A7B6-433DEFC688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A7880-7FED-EC42-A631-90F2C280090A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034BC9-EADE-E24C-9122-B228F810E0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173927-4B51-A84B-80D0-8C445693B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A87A67-1E05-7E41-BAD6-42C10BA68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900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41F09C4-6E94-004A-8F25-71C8D62DB5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D48DE0-6D32-494A-8777-794A452EFC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036338-DD9D-2E44-818F-6F9118B1D7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A7880-7FED-EC42-A631-90F2C280090A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7FFE5A-5174-5044-BE13-B57837B471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20109E-8EB3-D04E-B95F-1520C7ADA7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A87A67-1E05-7E41-BAD6-42C10BA68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489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1C640D7-7E88-2D42-A55C-877C575A4AE0}"/>
              </a:ext>
            </a:extLst>
          </p:cNvPr>
          <p:cNvGrpSpPr/>
          <p:nvPr/>
        </p:nvGrpSpPr>
        <p:grpSpPr>
          <a:xfrm>
            <a:off x="4568952" y="1850511"/>
            <a:ext cx="3054096" cy="3156978"/>
            <a:chOff x="4218790" y="854976"/>
            <a:chExt cx="3054096" cy="3156978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59CF170-00D2-5744-A5F9-BE3F17542C8E}"/>
                </a:ext>
              </a:extLst>
            </p:cNvPr>
            <p:cNvSpPr txBox="1"/>
            <p:nvPr/>
          </p:nvSpPr>
          <p:spPr>
            <a:xfrm>
              <a:off x="4433835" y="854976"/>
              <a:ext cx="1424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AB620A9-2E44-044A-B113-388A7C30CA2B}"/>
                </a:ext>
              </a:extLst>
            </p:cNvPr>
            <p:cNvSpPr txBox="1"/>
            <p:nvPr/>
          </p:nvSpPr>
          <p:spPr>
            <a:xfrm>
              <a:off x="5893154" y="885141"/>
              <a:ext cx="1424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1F1A4D37-4E62-454E-8F99-A563EBBC527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00877992"/>
                </p:ext>
              </p:extLst>
            </p:nvPr>
          </p:nvGraphicFramePr>
          <p:xfrm>
            <a:off x="4218790" y="1035703"/>
            <a:ext cx="1583488" cy="14227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CE15A1FF-AD92-D64A-AC11-9B1DAFD5564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22018202"/>
                </p:ext>
              </p:extLst>
            </p:nvPr>
          </p:nvGraphicFramePr>
          <p:xfrm>
            <a:off x="5689398" y="1035703"/>
            <a:ext cx="1583488" cy="14227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F0ACA34-6101-E44E-8FCC-05FD398C5BDF}"/>
                </a:ext>
              </a:extLst>
            </p:cNvPr>
            <p:cNvSpPr txBox="1"/>
            <p:nvPr/>
          </p:nvSpPr>
          <p:spPr>
            <a:xfrm>
              <a:off x="6757290" y="1993004"/>
              <a:ext cx="4066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73DA32A-FC97-E84E-BD81-968BC57EB151}"/>
                </a:ext>
              </a:extLst>
            </p:cNvPr>
            <p:cNvSpPr txBox="1"/>
            <p:nvPr/>
          </p:nvSpPr>
          <p:spPr>
            <a:xfrm>
              <a:off x="5328645" y="1993004"/>
              <a:ext cx="3037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graphicFrame>
          <p:nvGraphicFramePr>
            <p:cNvPr id="15" name="Chart 14">
              <a:extLst>
                <a:ext uri="{FF2B5EF4-FFF2-40B4-BE49-F238E27FC236}">
                  <a16:creationId xmlns:a16="http://schemas.microsoft.com/office/drawing/2014/main" id="{E595F87A-9687-2A48-8273-8BFC2466DC4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87535816"/>
                </p:ext>
              </p:extLst>
            </p:nvPr>
          </p:nvGraphicFramePr>
          <p:xfrm>
            <a:off x="4235856" y="2589238"/>
            <a:ext cx="1583488" cy="14227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A065451B-7795-E546-8920-B69CAE88E1E3}"/>
                </a:ext>
              </a:extLst>
            </p:cNvPr>
            <p:cNvSpPr/>
            <p:nvPr/>
          </p:nvSpPr>
          <p:spPr>
            <a:xfrm>
              <a:off x="5152119" y="2227139"/>
              <a:ext cx="678664" cy="1671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D974122-8AC7-364E-B5F6-A62CDADEFEB7}"/>
                </a:ext>
              </a:extLst>
            </p:cNvPr>
            <p:cNvSpPr txBox="1"/>
            <p:nvPr/>
          </p:nvSpPr>
          <p:spPr>
            <a:xfrm>
              <a:off x="5162394" y="2208448"/>
              <a:ext cx="5729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/>
                <a:t>ccdc22-1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87F0A1A3-EFC9-9347-9407-F4943F03F556}"/>
                </a:ext>
              </a:extLst>
            </p:cNvPr>
            <p:cNvSpPr/>
            <p:nvPr/>
          </p:nvSpPr>
          <p:spPr>
            <a:xfrm>
              <a:off x="6630108" y="2224520"/>
              <a:ext cx="526997" cy="1723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C2FEE4B-66EF-B74A-BBE4-04CDE064FDAC}"/>
                </a:ext>
              </a:extLst>
            </p:cNvPr>
            <p:cNvSpPr txBox="1"/>
            <p:nvPr/>
          </p:nvSpPr>
          <p:spPr>
            <a:xfrm>
              <a:off x="6630108" y="2204889"/>
              <a:ext cx="5953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/>
                <a:t>ccdc93-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EDAAC5E-4015-314F-AA7E-06785FD6FA6E}"/>
                </a:ext>
              </a:extLst>
            </p:cNvPr>
            <p:cNvSpPr txBox="1"/>
            <p:nvPr/>
          </p:nvSpPr>
          <p:spPr>
            <a:xfrm>
              <a:off x="4388679" y="2417494"/>
              <a:ext cx="1424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B619EF2-B32C-F94A-A3D6-E1E50F1BE0A5}"/>
                </a:ext>
              </a:extLst>
            </p:cNvPr>
            <p:cNvSpPr txBox="1"/>
            <p:nvPr/>
          </p:nvSpPr>
          <p:spPr>
            <a:xfrm>
              <a:off x="5299806" y="3562632"/>
              <a:ext cx="5520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***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D207AB12-F3B7-F045-BC60-0988B0A5452A}"/>
                </a:ext>
              </a:extLst>
            </p:cNvPr>
            <p:cNvSpPr/>
            <p:nvPr/>
          </p:nvSpPr>
          <p:spPr>
            <a:xfrm>
              <a:off x="5355958" y="3822183"/>
              <a:ext cx="595389" cy="15770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0B7D152-B446-0842-A82C-19159FD8C5E6}"/>
                </a:ext>
              </a:extLst>
            </p:cNvPr>
            <p:cNvSpPr txBox="1"/>
            <p:nvPr/>
          </p:nvSpPr>
          <p:spPr>
            <a:xfrm>
              <a:off x="5220249" y="3749921"/>
              <a:ext cx="5543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/>
                <a:t>ccdc93-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92126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3</Words>
  <Application>Microsoft Macintosh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or Lewis</dc:creator>
  <cp:lastModifiedBy>Connor Lewis</cp:lastModifiedBy>
  <cp:revision>2</cp:revision>
  <dcterms:created xsi:type="dcterms:W3CDTF">2022-09-13T16:51:08Z</dcterms:created>
  <dcterms:modified xsi:type="dcterms:W3CDTF">2022-11-18T19:10:55Z</dcterms:modified>
</cp:coreProperties>
</file>